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90"/>
    <p:restoredTop sz="94567" autoAdjust="0"/>
  </p:normalViewPr>
  <p:slideViewPr>
    <p:cSldViewPr snapToGrid="0" snapToObjects="1">
      <p:cViewPr>
        <p:scale>
          <a:sx n="150" d="100"/>
          <a:sy n="150" d="100"/>
        </p:scale>
        <p:origin x="760" y="160"/>
      </p:cViewPr>
      <p:guideLst>
        <p:guide orient="horz" pos="288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5" name="図 174"/>
          <p:cNvPicPr>
            <a:picLocks noChangeAspect="1"/>
          </p:cNvPicPr>
          <p:nvPr/>
        </p:nvPicPr>
        <p:blipFill rotWithShape="1">
          <a:blip r:embed="rId2"/>
          <a:srcRect l="12177" r="7436" b="6972"/>
          <a:stretch/>
        </p:blipFill>
        <p:spPr>
          <a:xfrm>
            <a:off x="5128836" y="2531183"/>
            <a:ext cx="1546985" cy="1114934"/>
          </a:xfrm>
          <a:prstGeom prst="rect">
            <a:avLst/>
          </a:prstGeom>
        </p:spPr>
      </p:pic>
      <p:pic>
        <p:nvPicPr>
          <p:cNvPr id="174" name="図 173"/>
          <p:cNvPicPr>
            <a:picLocks noChangeAspect="1"/>
          </p:cNvPicPr>
          <p:nvPr/>
        </p:nvPicPr>
        <p:blipFill rotWithShape="1">
          <a:blip r:embed="rId3"/>
          <a:srcRect l="13028" r="13398" b="11182"/>
          <a:stretch/>
        </p:blipFill>
        <p:spPr>
          <a:xfrm>
            <a:off x="2846504" y="2514759"/>
            <a:ext cx="1572919" cy="1141771"/>
          </a:xfrm>
          <a:prstGeom prst="rect">
            <a:avLst/>
          </a:prstGeom>
        </p:spPr>
      </p:pic>
      <p:pic>
        <p:nvPicPr>
          <p:cNvPr id="173" name="図 172"/>
          <p:cNvPicPr>
            <a:picLocks noChangeAspect="1"/>
          </p:cNvPicPr>
          <p:nvPr/>
        </p:nvPicPr>
        <p:blipFill rotWithShape="1">
          <a:blip r:embed="rId4"/>
          <a:srcRect l="8198" r="7387" b="7027"/>
          <a:stretch/>
        </p:blipFill>
        <p:spPr>
          <a:xfrm>
            <a:off x="563726" y="2504873"/>
            <a:ext cx="1574048" cy="1127834"/>
          </a:xfrm>
          <a:prstGeom prst="rect">
            <a:avLst/>
          </a:prstGeom>
        </p:spPr>
      </p:pic>
      <p:pic>
        <p:nvPicPr>
          <p:cNvPr id="168" name="図 167"/>
          <p:cNvPicPr>
            <a:picLocks noChangeAspect="1"/>
          </p:cNvPicPr>
          <p:nvPr/>
        </p:nvPicPr>
        <p:blipFill rotWithShape="1">
          <a:blip r:embed="rId5"/>
          <a:srcRect l="13111" r="13199" b="10619"/>
          <a:stretch/>
        </p:blipFill>
        <p:spPr>
          <a:xfrm>
            <a:off x="5137782" y="946963"/>
            <a:ext cx="1556722" cy="1135396"/>
          </a:xfrm>
          <a:prstGeom prst="rect">
            <a:avLst/>
          </a:prstGeom>
        </p:spPr>
      </p:pic>
      <p:pic>
        <p:nvPicPr>
          <p:cNvPr id="165" name="図 164"/>
          <p:cNvPicPr>
            <a:picLocks noChangeAspect="1"/>
          </p:cNvPicPr>
          <p:nvPr/>
        </p:nvPicPr>
        <p:blipFill rotWithShape="1">
          <a:blip r:embed="rId6"/>
          <a:srcRect l="7624" r="8324" b="8386"/>
          <a:stretch/>
        </p:blipFill>
        <p:spPr>
          <a:xfrm>
            <a:off x="2842909" y="952671"/>
            <a:ext cx="1544770" cy="1103569"/>
          </a:xfrm>
          <a:prstGeom prst="rect">
            <a:avLst/>
          </a:prstGeom>
        </p:spPr>
      </p:pic>
      <p:pic>
        <p:nvPicPr>
          <p:cNvPr id="163" name="図 162"/>
          <p:cNvPicPr>
            <a:picLocks noChangeAspect="1"/>
          </p:cNvPicPr>
          <p:nvPr/>
        </p:nvPicPr>
        <p:blipFill rotWithShape="1">
          <a:blip r:embed="rId7"/>
          <a:srcRect l="13023" r="13700" b="12359"/>
          <a:stretch/>
        </p:blipFill>
        <p:spPr>
          <a:xfrm>
            <a:off x="578354" y="967659"/>
            <a:ext cx="1537338" cy="110559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1090207" y="2020665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ZIK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1531685" y="2020665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600489" y="202066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083891" y="753799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L2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375276" y="732979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CL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73252" y="1876409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373252" y="1211265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-33156" y="1039034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1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2634077" y="1873840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2634077" y="1666778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2634077" y="1471461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634077" y="1280001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634077" y="1077471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678436" y="739919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CL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365628" y="90205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365628" y="153985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634077" y="879286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119028" y="2262829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L7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343445" y="2262829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CL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2594196" y="3443130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2593668" y="3263828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2594196" y="3061572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594196" y="2877051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594196" y="2688401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554185" y="2262829"/>
            <a:ext cx="6721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CL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916660" y="3461124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908772" y="3185433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833488" y="2948098"/>
            <a:ext cx="345799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825600" y="2693672"/>
            <a:ext cx="345799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601298" y="2490217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1176860" y="967425"/>
            <a:ext cx="459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***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1471871" y="1753944"/>
            <a:ext cx="6524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N.S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 rot="16200000">
            <a:off x="2220902" y="1032032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1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3452163" y="987882"/>
            <a:ext cx="459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***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3738220" y="1739562"/>
            <a:ext cx="6524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N.S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938329" y="1865634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938329" y="1664515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38329" y="1464845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30705" y="126666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 rot="16200000">
            <a:off x="4495418" y="1015938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1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30705" y="108189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845119" y="911212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5728896" y="903258"/>
            <a:ext cx="459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***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6012085" y="1755116"/>
            <a:ext cx="6524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N.S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 rot="16200000">
            <a:off x="-49761" y="2620335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2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 rot="16200000">
            <a:off x="-749969" y="2626669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 rot="16200000">
            <a:off x="2219631" y="2620754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4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 rot="16200000">
            <a:off x="1510235" y="2609123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 rot="16200000">
            <a:off x="4488111" y="2629408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4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 rot="16200000">
            <a:off x="3786532" y="2589307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3363328" y="2020665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ZIK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3804806" y="2020665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5649425" y="2020665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ZIK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6090903" y="2020665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3324861" y="358319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ZIK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3766339" y="357933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5627568" y="3568307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ZIK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6069046" y="3564452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1034526" y="3572979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ZIK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2A3321E8-A6B8-CC46-829B-47981A12AF76}"/>
              </a:ext>
            </a:extLst>
          </p:cNvPr>
          <p:cNvSpPr txBox="1"/>
          <p:nvPr/>
        </p:nvSpPr>
        <p:spPr>
          <a:xfrm>
            <a:off x="1476004" y="3576064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56590" y="3427377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287722" y="2789993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287190" y="2480782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356590" y="311164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1167608" y="2447555"/>
            <a:ext cx="459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***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1463255" y="3300202"/>
            <a:ext cx="6524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N.S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3463619" y="2439667"/>
            <a:ext cx="459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***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3753048" y="3184557"/>
            <a:ext cx="6524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N.S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839226" y="244522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5750759" y="2600903"/>
            <a:ext cx="459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**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6009415" y="3143976"/>
            <a:ext cx="6524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N.S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2876174" y="202066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5171769" y="202066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565379" y="3584844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2859951" y="3582187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5133125" y="3569124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 rot="16200000">
            <a:off x="-639085" y="1096584"/>
            <a:ext cx="16767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 rot="16200000">
            <a:off x="1615549" y="1096584"/>
            <a:ext cx="16767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 rot="16200000">
            <a:off x="3888509" y="1096584"/>
            <a:ext cx="16767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7" name="テキスト ボックス 45"/>
          <p:cNvSpPr txBox="1">
            <a:spLocks noChangeArrowheads="1"/>
          </p:cNvSpPr>
          <p:nvPr/>
        </p:nvSpPr>
        <p:spPr bwMode="auto">
          <a:xfrm>
            <a:off x="1122962" y="32098"/>
            <a:ext cx="584647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>
                <a:latin typeface="Helvetica"/>
                <a:cs typeface="Helvetica"/>
              </a:rPr>
              <a:t>Supplementary </a:t>
            </a:r>
            <a:r>
              <a:rPr lang="en-US" altLang="ja-JP" smtClean="0">
                <a:latin typeface="Helvetica"/>
                <a:cs typeface="Helvetica"/>
              </a:rPr>
              <a:t>Fig.S10_Kamiyama </a:t>
            </a:r>
            <a:r>
              <a:rPr lang="en-US" altLang="ja-JP" dirty="0">
                <a:latin typeface="Helvetica"/>
                <a:cs typeface="Helvetica"/>
              </a:rPr>
              <a:t>et al.</a:t>
            </a:r>
            <a:endParaRPr lang="ja-JP" altLang="en-US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97463960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7</TotalTime>
  <Words>133</Words>
  <Application>Microsoft Macintosh PowerPoint</Application>
  <PresentationFormat>画面に合わせる (4:3)</PresentationFormat>
  <Paragraphs>8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ＭＳ Ｐゴシック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神山長慶</cp:lastModifiedBy>
  <cp:revision>329</cp:revision>
  <cp:lastPrinted>2024-05-22T05:30:17Z</cp:lastPrinted>
  <dcterms:created xsi:type="dcterms:W3CDTF">2022-03-10T04:52:23Z</dcterms:created>
  <dcterms:modified xsi:type="dcterms:W3CDTF">2025-11-05T08:06:32Z</dcterms:modified>
  <cp:category/>
</cp:coreProperties>
</file>